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5"/>
  </p:notesMasterIdLst>
  <p:sldIdLst>
    <p:sldId id="256" r:id="rId2"/>
    <p:sldId id="260" r:id="rId3"/>
    <p:sldId id="263" r:id="rId4"/>
    <p:sldId id="264" r:id="rId5"/>
    <p:sldId id="267" r:id="rId6"/>
    <p:sldId id="272" r:id="rId7"/>
    <p:sldId id="273" r:id="rId8"/>
    <p:sldId id="274" r:id="rId9"/>
    <p:sldId id="278" r:id="rId10"/>
    <p:sldId id="281" r:id="rId11"/>
    <p:sldId id="283" r:id="rId12"/>
    <p:sldId id="269" r:id="rId13"/>
    <p:sldId id="257" r:id="rId14"/>
    <p:sldId id="265" r:id="rId15"/>
    <p:sldId id="266" r:id="rId16"/>
    <p:sldId id="268" r:id="rId17"/>
    <p:sldId id="270" r:id="rId18"/>
    <p:sldId id="271" r:id="rId19"/>
    <p:sldId id="275" r:id="rId20"/>
    <p:sldId id="276" r:id="rId21"/>
    <p:sldId id="277" r:id="rId22"/>
    <p:sldId id="279" r:id="rId23"/>
    <p:sldId id="282" r:id="rId2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71" d="100"/>
          <a:sy n="71" d="100"/>
        </p:scale>
        <p:origin x="96" y="26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</a:defRPr>
            </a:lvl1pPr>
          </a:lstStyle>
          <a:p>
            <a:endParaRPr lang="ko-KR" altLang="en-US" dirty="0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</a:defRPr>
            </a:lvl1pPr>
          </a:lstStyle>
          <a:p>
            <a:fld id="{D1C86A6A-1AFF-4F5D-A569-676C8A7BC3B0}" type="datetimeFigureOut">
              <a:rPr lang="ko-KR" altLang="en-US" smtClean="0"/>
              <a:pPr/>
              <a:t>2019-12-12</a:t>
            </a:fld>
            <a:endParaRPr lang="ko-KR" altLang="en-US" dirty="0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 dirty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dirty="0" smtClean="0"/>
              <a:t>마스터 텍스트 스타일을 편집합니다</a:t>
            </a:r>
          </a:p>
          <a:p>
            <a:pPr lvl="1"/>
            <a:r>
              <a:rPr lang="ko-KR" altLang="en-US" dirty="0" smtClean="0"/>
              <a:t>둘째 수준</a:t>
            </a:r>
          </a:p>
          <a:p>
            <a:pPr lvl="2"/>
            <a:r>
              <a:rPr lang="ko-KR" altLang="en-US" dirty="0" smtClean="0"/>
              <a:t>셋째 수준</a:t>
            </a:r>
          </a:p>
          <a:p>
            <a:pPr lvl="3"/>
            <a:r>
              <a:rPr lang="ko-KR" altLang="en-US" dirty="0" smtClean="0"/>
              <a:t>넷째 수준</a:t>
            </a:r>
          </a:p>
          <a:p>
            <a:pPr lvl="4"/>
            <a:r>
              <a:rPr lang="ko-KR" altLang="en-US" dirty="0" smtClean="0"/>
              <a:t>다섯째 수준</a:t>
            </a:r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</a:defRPr>
            </a:lvl1pPr>
          </a:lstStyle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</a:defRPr>
            </a:lvl1pPr>
          </a:lstStyle>
          <a:p>
            <a:fld id="{AFA39A9B-8F98-4623-AF34-C80F54487770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754915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Arial Unicode MS" panose="020B0604020202020204" pitchFamily="50" charset="-127"/>
        <a:ea typeface="Arial Unicode MS" panose="020B0604020202020204" pitchFamily="50" charset="-127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Arial Unicode MS" panose="020B0604020202020204" pitchFamily="50" charset="-127"/>
        <a:ea typeface="Arial Unicode MS" panose="020B0604020202020204" pitchFamily="50" charset="-127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Arial Unicode MS" panose="020B0604020202020204" pitchFamily="50" charset="-127"/>
        <a:ea typeface="Arial Unicode MS" panose="020B0604020202020204" pitchFamily="50" charset="-127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Arial Unicode MS" panose="020B0604020202020204" pitchFamily="50" charset="-127"/>
        <a:ea typeface="Arial Unicode MS" panose="020B0604020202020204" pitchFamily="50" charset="-127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Arial Unicode MS" panose="020B0604020202020204" pitchFamily="50" charset="-127"/>
        <a:ea typeface="Arial Unicode MS" panose="020B0604020202020204" pitchFamily="50" charset="-127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mtClean="0"/>
              <a:t>17175832 </a:t>
            </a:r>
            <a:r>
              <a:rPr lang="ko-KR" altLang="en-US" smtClean="0"/>
              <a:t>김상호 </a:t>
            </a:r>
            <a:r>
              <a:rPr lang="en-US" altLang="ko-KR" smtClean="0"/>
              <a:t>2010-12-17</a:t>
            </a:r>
          </a:p>
          <a:p>
            <a:r>
              <a:rPr lang="en-US" altLang="ko-KR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2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74663238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48644091 </a:t>
            </a:r>
            <a:r>
              <a:rPr lang="ko-KR" altLang="en-US" smtClean="0"/>
              <a:t>장현진</a:t>
            </a:r>
            <a:r>
              <a:rPr lang="en-US" altLang="ko-KR" smtClean="0"/>
              <a:t> 2018-04-06</a:t>
            </a:r>
          </a:p>
          <a:p>
            <a:r>
              <a:rPr lang="en-US" altLang="ko-KR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11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14139178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36796999 </a:t>
            </a:r>
            <a:r>
              <a:rPr lang="ko-KR" altLang="en-US" dirty="0" smtClean="0"/>
              <a:t>박수원 </a:t>
            </a:r>
            <a:r>
              <a:rPr lang="en-US" altLang="ko-KR" dirty="0" smtClean="0"/>
              <a:t>2013-01-22</a:t>
            </a:r>
          </a:p>
          <a:p>
            <a:r>
              <a:rPr lang="en-US" altLang="ko-KR" dirty="0" smtClean="0"/>
              <a:t>Ok </a:t>
            </a:r>
            <a:r>
              <a:rPr lang="ko-KR" altLang="en-US" dirty="0" err="1" smtClean="0"/>
              <a:t>이환자는</a:t>
            </a:r>
            <a:r>
              <a:rPr lang="ko-KR" altLang="en-US" dirty="0" smtClean="0"/>
              <a:t> </a:t>
            </a:r>
            <a:r>
              <a:rPr lang="en-US" altLang="ko-KR" dirty="0" smtClean="0"/>
              <a:t>2012-1-5 thyroid</a:t>
            </a:r>
            <a:r>
              <a:rPr lang="en-US" altLang="ko-KR" baseline="0" dirty="0" smtClean="0"/>
              <a:t> CT</a:t>
            </a:r>
            <a:r>
              <a:rPr lang="ko-KR" altLang="en-US" baseline="0" dirty="0" smtClean="0"/>
              <a:t>에서 </a:t>
            </a:r>
            <a:r>
              <a:rPr lang="en-US" altLang="ko-KR" baseline="0" dirty="0" smtClean="0"/>
              <a:t>cover</a:t>
            </a:r>
            <a:r>
              <a:rPr lang="ko-KR" altLang="en-US" baseline="0" dirty="0" smtClean="0"/>
              <a:t>되었으며 </a:t>
            </a:r>
            <a:r>
              <a:rPr lang="en-US" altLang="ko-KR" baseline="0" dirty="0" smtClean="0"/>
              <a:t>FU </a:t>
            </a:r>
            <a:r>
              <a:rPr lang="ko-KR" altLang="en-US" baseline="0" dirty="0" smtClean="0"/>
              <a:t>있는 </a:t>
            </a:r>
            <a:r>
              <a:rPr lang="ko-KR" altLang="en-US" baseline="0" dirty="0" err="1" smtClean="0"/>
              <a:t>환자군으로</a:t>
            </a:r>
            <a:r>
              <a:rPr lang="ko-KR" altLang="en-US" baseline="0" dirty="0" smtClean="0"/>
              <a:t> 분석하자</a:t>
            </a:r>
            <a:r>
              <a:rPr lang="en-US" altLang="ko-KR" baseline="0" dirty="0" smtClean="0"/>
              <a:t>!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12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3168810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13976468 </a:t>
            </a:r>
            <a:r>
              <a:rPr lang="ko-KR" altLang="en-US" smtClean="0"/>
              <a:t>노만식 </a:t>
            </a:r>
            <a:r>
              <a:rPr lang="en-US" altLang="ko-KR" smtClean="0"/>
              <a:t>2017-12-13</a:t>
            </a:r>
          </a:p>
          <a:p>
            <a:r>
              <a:rPr lang="en-US" altLang="ko-KR" smtClean="0"/>
              <a:t>Ok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13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4977586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28782944 </a:t>
            </a:r>
            <a:r>
              <a:rPr lang="ko-KR" altLang="en-US" dirty="0" smtClean="0"/>
              <a:t>권수현 </a:t>
            </a:r>
            <a:r>
              <a:rPr lang="en-US" altLang="ko-KR" dirty="0" smtClean="0"/>
              <a:t>2016-04-04</a:t>
            </a:r>
          </a:p>
          <a:p>
            <a:r>
              <a:rPr lang="en-US" altLang="ko-KR" dirty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14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11637985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31373771 </a:t>
            </a:r>
            <a:r>
              <a:rPr lang="ko-KR" altLang="en-US" dirty="0" smtClean="0"/>
              <a:t>전정연 </a:t>
            </a:r>
            <a:r>
              <a:rPr lang="en-US" altLang="ko-KR" dirty="0" smtClean="0"/>
              <a:t>2013-11-14 </a:t>
            </a:r>
          </a:p>
          <a:p>
            <a:r>
              <a:rPr lang="en-US" altLang="ko-KR" dirty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15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105911200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36231865 </a:t>
            </a:r>
            <a:r>
              <a:rPr lang="ko-KR" altLang="en-US" dirty="0" smtClean="0"/>
              <a:t>이강희</a:t>
            </a:r>
            <a:r>
              <a:rPr lang="en-US" altLang="ko-KR" dirty="0" smtClean="0"/>
              <a:t> 2017-02-09</a:t>
            </a:r>
          </a:p>
          <a:p>
            <a:r>
              <a:rPr lang="en-US" altLang="ko-KR" dirty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16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65128945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37603540 </a:t>
            </a:r>
            <a:r>
              <a:rPr lang="ko-KR" altLang="en-US" dirty="0" smtClean="0"/>
              <a:t>장우석 </a:t>
            </a:r>
            <a:r>
              <a:rPr lang="en-US" altLang="ko-KR" dirty="0" smtClean="0"/>
              <a:t>2015-05-06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17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8750100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38519934</a:t>
            </a:r>
            <a:r>
              <a:rPr lang="en-US" altLang="ko-KR" baseline="0" dirty="0" smtClean="0"/>
              <a:t> </a:t>
            </a:r>
            <a:r>
              <a:rPr lang="ko-KR" altLang="en-US" baseline="0" dirty="0" smtClean="0"/>
              <a:t>김시현 </a:t>
            </a:r>
            <a:r>
              <a:rPr lang="en-US" altLang="ko-KR" baseline="0" dirty="0" smtClean="0"/>
              <a:t>2016-08-05</a:t>
            </a:r>
          </a:p>
          <a:p>
            <a:r>
              <a:rPr lang="en-US" altLang="ko-KR" baseline="0" dirty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18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1511320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39995005 </a:t>
            </a:r>
            <a:r>
              <a:rPr lang="ko-KR" altLang="en-US" dirty="0" smtClean="0"/>
              <a:t>이동운 </a:t>
            </a:r>
            <a:r>
              <a:rPr lang="en-US" altLang="ko-KR" dirty="0" smtClean="0"/>
              <a:t>2014-08-04</a:t>
            </a:r>
          </a:p>
          <a:p>
            <a:r>
              <a:rPr lang="en-US" altLang="ko-KR" dirty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19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9986590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40464354 </a:t>
            </a:r>
            <a:r>
              <a:rPr lang="ko-KR" altLang="en-US" dirty="0" smtClean="0"/>
              <a:t>주종배 </a:t>
            </a:r>
            <a:r>
              <a:rPr lang="en-US" altLang="ko-KR" dirty="0" smtClean="0"/>
              <a:t>2018-05-25</a:t>
            </a:r>
          </a:p>
          <a:p>
            <a:r>
              <a:rPr lang="en-US" altLang="ko-KR" dirty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20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172584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25823808</a:t>
            </a:r>
            <a:r>
              <a:rPr lang="en-US" altLang="ko-KR" baseline="0" dirty="0" smtClean="0"/>
              <a:t> </a:t>
            </a:r>
            <a:r>
              <a:rPr lang="ko-KR" altLang="en-US" baseline="0" dirty="0" smtClean="0"/>
              <a:t>유덕준 </a:t>
            </a:r>
            <a:r>
              <a:rPr lang="en-US" altLang="ko-KR" baseline="0" smtClean="0"/>
              <a:t>2007-02-07 </a:t>
            </a:r>
          </a:p>
          <a:p>
            <a:r>
              <a:rPr lang="en-US" altLang="ko-KR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3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105083159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46150879 </a:t>
            </a:r>
            <a:r>
              <a:rPr lang="ko-KR" altLang="en-US" dirty="0" smtClean="0"/>
              <a:t>박정환 </a:t>
            </a:r>
            <a:r>
              <a:rPr lang="en-US" altLang="ko-KR" dirty="0" smtClean="0"/>
              <a:t>2014-11-20</a:t>
            </a:r>
          </a:p>
          <a:p>
            <a:r>
              <a:rPr lang="en-US" altLang="ko-KR" dirty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2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5142199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mtClean="0"/>
              <a:t>47767388 </a:t>
            </a:r>
            <a:r>
              <a:rPr lang="ko-KR" altLang="en-US" smtClean="0"/>
              <a:t>전병철 </a:t>
            </a:r>
            <a:r>
              <a:rPr lang="en-US" altLang="ko-KR" smtClean="0"/>
              <a:t>2016-01-21</a:t>
            </a:r>
          </a:p>
          <a:p>
            <a:r>
              <a:rPr lang="en-US" altLang="ko-KR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2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3380329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70768709</a:t>
            </a:r>
            <a:r>
              <a:rPr lang="en-US" altLang="ko-KR" baseline="0" dirty="0" smtClean="0"/>
              <a:t> </a:t>
            </a:r>
            <a:r>
              <a:rPr lang="ko-KR" altLang="en-US" baseline="0" smtClean="0"/>
              <a:t>조기대 </a:t>
            </a:r>
            <a:r>
              <a:rPr lang="en-US" altLang="ko-KR" baseline="0" smtClean="0"/>
              <a:t>2016-03-09</a:t>
            </a:r>
          </a:p>
          <a:p>
            <a:r>
              <a:rPr lang="en-US" altLang="ko-KR" baseline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23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305946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28392738 </a:t>
            </a:r>
            <a:r>
              <a:rPr lang="ko-KR" altLang="en-US" dirty="0" smtClean="0"/>
              <a:t>강영복</a:t>
            </a:r>
            <a:r>
              <a:rPr lang="en-US" altLang="ko-KR" dirty="0" smtClean="0"/>
              <a:t> 2010-03-18</a:t>
            </a:r>
          </a:p>
          <a:p>
            <a:r>
              <a:rPr lang="en-US" altLang="ko-KR" dirty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4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3374001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33941341 </a:t>
            </a:r>
            <a:r>
              <a:rPr lang="ko-KR" altLang="en-US" dirty="0" smtClean="0"/>
              <a:t>정인철</a:t>
            </a:r>
            <a:r>
              <a:rPr lang="en-US" altLang="ko-KR" dirty="0" smtClean="0"/>
              <a:t> 2013-10-21</a:t>
            </a:r>
          </a:p>
          <a:p>
            <a:r>
              <a:rPr lang="en-US" altLang="ko-KR" dirty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5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5801663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38952555</a:t>
            </a:r>
            <a:r>
              <a:rPr lang="en-US" altLang="ko-KR" baseline="0" dirty="0" smtClean="0"/>
              <a:t> </a:t>
            </a:r>
            <a:r>
              <a:rPr lang="ko-KR" altLang="en-US" baseline="0" dirty="0" smtClean="0"/>
              <a:t>차미숙 </a:t>
            </a:r>
            <a:r>
              <a:rPr lang="en-US" altLang="ko-KR" baseline="0" dirty="0" smtClean="0"/>
              <a:t>2009-05-16</a:t>
            </a:r>
          </a:p>
          <a:p>
            <a:r>
              <a:rPr lang="en-US" altLang="ko-KR" dirty="0" smtClean="0"/>
              <a:t>Ok</a:t>
            </a: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6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0283170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39059529 </a:t>
            </a:r>
            <a:r>
              <a:rPr lang="ko-KR" altLang="en-US" dirty="0" smtClean="0"/>
              <a:t>구경열 </a:t>
            </a:r>
            <a:r>
              <a:rPr lang="en-US" altLang="ko-KR" dirty="0" smtClean="0"/>
              <a:t>2009-06-02</a:t>
            </a:r>
          </a:p>
          <a:p>
            <a:r>
              <a:rPr lang="en-US" altLang="ko-KR" dirty="0" smtClean="0"/>
              <a:t>Ok.</a:t>
            </a:r>
            <a:r>
              <a:rPr lang="en-US" altLang="ko-KR" baseline="0" dirty="0" smtClean="0"/>
              <a:t> Interval CT</a:t>
            </a:r>
            <a:r>
              <a:rPr lang="ko-KR" altLang="en-US" baseline="0" dirty="0" smtClean="0"/>
              <a:t>있고 </a:t>
            </a:r>
            <a:r>
              <a:rPr lang="en-US" altLang="ko-KR" baseline="0" dirty="0" smtClean="0"/>
              <a:t>2011</a:t>
            </a:r>
            <a:r>
              <a:rPr lang="ko-KR" altLang="en-US" baseline="0" dirty="0" smtClean="0"/>
              <a:t>년 </a:t>
            </a:r>
            <a:r>
              <a:rPr lang="en-US" altLang="ko-KR" baseline="0" dirty="0" smtClean="0"/>
              <a:t>CT</a:t>
            </a:r>
            <a:r>
              <a:rPr lang="ko-KR" altLang="en-US" baseline="0" dirty="0" smtClean="0"/>
              <a:t>와 변화가 없다가 </a:t>
            </a:r>
            <a:r>
              <a:rPr lang="en-US" altLang="ko-KR" baseline="0" dirty="0" smtClean="0"/>
              <a:t>2013</a:t>
            </a:r>
            <a:r>
              <a:rPr lang="ko-KR" altLang="en-US" baseline="0" dirty="0" smtClean="0"/>
              <a:t>년 </a:t>
            </a:r>
            <a:r>
              <a:rPr lang="en-US" altLang="ko-KR" baseline="0" dirty="0" smtClean="0"/>
              <a:t>CT</a:t>
            </a:r>
            <a:r>
              <a:rPr lang="ko-KR" altLang="en-US" baseline="0" dirty="0" smtClean="0"/>
              <a:t>에서 일부 </a:t>
            </a:r>
            <a:r>
              <a:rPr lang="en-US" altLang="ko-KR" baseline="0" dirty="0" smtClean="0"/>
              <a:t>active</a:t>
            </a:r>
            <a:r>
              <a:rPr lang="ko-KR" altLang="en-US" baseline="0" dirty="0" smtClean="0"/>
              <a:t>로 전환</a:t>
            </a:r>
            <a:r>
              <a:rPr lang="en-US" altLang="ko-KR" baseline="0" dirty="0" smtClean="0"/>
              <a:t>. Typical</a:t>
            </a:r>
            <a:r>
              <a:rPr lang="ko-KR" altLang="en-US" baseline="0" dirty="0" smtClean="0"/>
              <a:t>한 </a:t>
            </a:r>
            <a:r>
              <a:rPr lang="en-US" altLang="ko-KR" baseline="0" dirty="0" smtClean="0"/>
              <a:t>course</a:t>
            </a:r>
            <a:r>
              <a:rPr lang="ko-KR" altLang="en-US" baseline="0" dirty="0" smtClean="0"/>
              <a:t>를 보여주는 듯 하구나</a:t>
            </a:r>
            <a:endParaRPr lang="en-US" altLang="ko-KR" baseline="0" dirty="0" smtClean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7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4446807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39498643 </a:t>
            </a:r>
            <a:r>
              <a:rPr lang="ko-KR" altLang="en-US" dirty="0" smtClean="0"/>
              <a:t>서두원 </a:t>
            </a:r>
            <a:r>
              <a:rPr lang="en-US" altLang="ko-KR" dirty="0" smtClean="0"/>
              <a:t>2014-10-22</a:t>
            </a:r>
          </a:p>
          <a:p>
            <a:r>
              <a:rPr lang="en-US" altLang="ko-KR" dirty="0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8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67723903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47251155 </a:t>
            </a:r>
            <a:r>
              <a:rPr lang="ko-KR" altLang="en-US" dirty="0" smtClean="0"/>
              <a:t>고석빈 </a:t>
            </a:r>
            <a:r>
              <a:rPr lang="en-US" altLang="ko-KR" smtClean="0"/>
              <a:t>2014-02-19 </a:t>
            </a:r>
          </a:p>
          <a:p>
            <a:r>
              <a:rPr lang="en-US" altLang="ko-KR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297553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50502222 </a:t>
            </a:r>
            <a:r>
              <a:rPr lang="ko-KR" altLang="en-US" smtClean="0"/>
              <a:t>함종식 </a:t>
            </a:r>
            <a:r>
              <a:rPr lang="en-US" altLang="ko-KR" smtClean="0"/>
              <a:t>2018-01-30</a:t>
            </a:r>
          </a:p>
          <a:p>
            <a:r>
              <a:rPr lang="en-US" altLang="ko-KR" smtClean="0"/>
              <a:t>Ok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A1B7FF-862C-4BB9-9B48-30B0719B78BF}" type="slidenum">
              <a:rPr lang="ko-KR" altLang="en-US" smtClean="0"/>
              <a:t>10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710400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2201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8016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3609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8511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5254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5137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5784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8427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7854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9095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C26D0-00CB-4688-AC8B-D10691CA1AF7}" type="datetimeFigureOut">
              <a:rPr lang="ko-KR" altLang="en-US" smtClean="0"/>
              <a:t>2019-12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5248E-AB9B-441C-AEF1-24811C178A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62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dirty="0" smtClean="0"/>
              <a:t>마스터 제목 스타일 편집</a:t>
            </a:r>
            <a:endParaRPr lang="ko-KR" altLang="en-US" dirty="0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dirty="0" smtClean="0"/>
              <a:t>마스터 텍스트 스타일을 편집합니다</a:t>
            </a:r>
          </a:p>
          <a:p>
            <a:pPr lvl="1"/>
            <a:r>
              <a:rPr lang="ko-KR" altLang="en-US" dirty="0" smtClean="0"/>
              <a:t>둘째 수준</a:t>
            </a:r>
          </a:p>
          <a:p>
            <a:pPr lvl="2"/>
            <a:r>
              <a:rPr lang="ko-KR" altLang="en-US" dirty="0" smtClean="0"/>
              <a:t>셋째 수준</a:t>
            </a:r>
          </a:p>
          <a:p>
            <a:pPr lvl="3"/>
            <a:r>
              <a:rPr lang="ko-KR" altLang="en-US" dirty="0" smtClean="0"/>
              <a:t>넷째 수준</a:t>
            </a:r>
          </a:p>
          <a:p>
            <a:pPr lvl="4"/>
            <a:r>
              <a:rPr lang="ko-KR" altLang="en-US" dirty="0" smtClean="0"/>
              <a:t>다섯째 수준</a:t>
            </a:r>
            <a:endParaRPr lang="ko-KR" altLang="en-US" dirty="0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</a:defRPr>
            </a:lvl1pPr>
          </a:lstStyle>
          <a:p>
            <a:fld id="{1A5C26D0-00CB-4688-AC8B-D10691CA1AF7}" type="datetimeFigureOut">
              <a:rPr lang="ko-KR" altLang="en-US" smtClean="0"/>
              <a:pPr/>
              <a:t>2019-12-1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</a:defRPr>
            </a:lvl1pPr>
          </a:lstStyle>
          <a:p>
            <a:fld id="{09E5248E-AB9B-441C-AEF1-24811C178AAD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84112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Arial Unicode MS" panose="020B0604020202020204" pitchFamily="50" charset="-127"/>
          <a:ea typeface="Arial Unicode MS" panose="020B0604020202020204" pitchFamily="50" charset="-127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Arial Unicode MS" panose="020B0604020202020204" pitchFamily="50" charset="-127"/>
          <a:ea typeface="Arial Unicode MS" panose="020B0604020202020204" pitchFamily="50" charset="-127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 Unicode MS" panose="020B0604020202020204" pitchFamily="50" charset="-127"/>
          <a:ea typeface="Arial Unicode MS" panose="020B0604020202020204" pitchFamily="50" charset="-127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Arial Unicode MS" panose="020B0604020202020204" pitchFamily="50" charset="-127"/>
          <a:ea typeface="Arial Unicode MS" panose="020B0604020202020204" pitchFamily="50" charset="-127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 Unicode MS" panose="020B0604020202020204" pitchFamily="50" charset="-127"/>
          <a:ea typeface="Arial Unicode MS" panose="020B0604020202020204" pitchFamily="50" charset="-127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 Unicode MS" panose="020B0604020202020204" pitchFamily="50" charset="-127"/>
          <a:ea typeface="Arial Unicode MS" panose="020B0604020202020204" pitchFamily="50" charset="-127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altLang="ko-KR" dirty="0" smtClean="0">
                <a:cs typeface="Arial Unicode MS" panose="020B0604020202020204" pitchFamily="50" charset="-127"/>
              </a:rPr>
              <a:t>Representative figures</a:t>
            </a:r>
            <a:r>
              <a:rPr lang="en-US" altLang="ko-KR" dirty="0" smtClean="0">
                <a:cs typeface="Arial Unicode MS" panose="020B0604020202020204" pitchFamily="50" charset="-127"/>
              </a:rPr>
              <a:t> </a:t>
            </a:r>
            <a:r>
              <a:rPr lang="en-US" altLang="ko-KR" dirty="0" smtClean="0">
                <a:cs typeface="Arial Unicode MS" panose="020B0604020202020204" pitchFamily="50" charset="-127"/>
              </a:rPr>
              <a:t>of 22 Patients with predominant CMs</a:t>
            </a:r>
            <a:endParaRPr lang="ko-KR" altLang="en-US" dirty="0"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5592191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0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9) ID 9, 65/M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CT: 2017-09-23</a:t>
            </a: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8-03-19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660618" y="2464353"/>
            <a:ext cx="350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– 2017-09-23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737399" y="2464353"/>
            <a:ext cx="3116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– 2018-03-19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642064" y="276999"/>
            <a:ext cx="169790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 : 4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 : 5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013552"/>
            <a:ext cx="6566788" cy="3405648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99358" y="3013552"/>
            <a:ext cx="5792642" cy="3405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416124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0"/>
            <a:ext cx="1079798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0) ID 10, 57/M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CT: 2015-02-24</a:t>
            </a: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8-07-01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697157" y="1677637"/>
            <a:ext cx="350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– 2013-10-15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502095" y="1630519"/>
            <a:ext cx="3116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– 2018-07-01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502095" y="489349"/>
            <a:ext cx="169790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 : 1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 : 3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364" y="2165386"/>
            <a:ext cx="5598739" cy="3975256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61006" y="2165386"/>
            <a:ext cx="5598739" cy="39395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65409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0" y="-6209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1) ID 11, 45/F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: 2012-01-05</a:t>
            </a: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3-01-22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94988" y="1955675"/>
            <a:ext cx="350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– 2012-01-05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520464" y="1955675"/>
            <a:ext cx="3116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– 2013-01-22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520464" y="727561"/>
            <a:ext cx="17459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 : 12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 : 14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936" y="2410451"/>
            <a:ext cx="5690128" cy="3930464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14013" y="2398669"/>
            <a:ext cx="5929463" cy="3930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825500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0" y="0"/>
            <a:ext cx="2964658" cy="17543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2) ID 12, 66/M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7-12-13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4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85855" y="1327990"/>
            <a:ext cx="7145341" cy="43601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48426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0"/>
            <a:ext cx="2964658" cy="17543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3) ID 13, 50/F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6-04-04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4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2690" y="1294559"/>
            <a:ext cx="6812307" cy="415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946130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13447"/>
            <a:ext cx="4182035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4) ID 14, 31/F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3-11-14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12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8579" y="936777"/>
            <a:ext cx="7940938" cy="5266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057731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0"/>
            <a:ext cx="2964658" cy="17543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5) ID 15, 49/M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7-02-09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7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8489" y="1134018"/>
            <a:ext cx="7635293" cy="4554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907519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0"/>
            <a:ext cx="1132242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6) ID 16, 54/M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5-04-24 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4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0278" y="795337"/>
            <a:ext cx="7597191" cy="50810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169511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0" y="0"/>
            <a:ext cx="2964658" cy="17543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7) ID 17, 82/M</a:t>
            </a:r>
            <a:endParaRPr lang="en-US" altLang="ko-KR" baseline="0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baseline="0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6-08-05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17</a:t>
            </a:r>
          </a:p>
          <a:p>
            <a:endParaRPr lang="en-US" altLang="ko-KR" baseline="0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75529" y="795617"/>
            <a:ext cx="7445188" cy="5335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45163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0"/>
            <a:ext cx="2964658" cy="17543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8) ID 18, 34/M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4-08-04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8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89499" y="923330"/>
            <a:ext cx="7756305" cy="47109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2167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0" y="0"/>
            <a:ext cx="535554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) ID : 1, 78/M</a:t>
            </a:r>
          </a:p>
          <a:p>
            <a:pPr marL="285750" indent="-285750">
              <a:buFontTx/>
              <a:buChar char="-"/>
            </a:pP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CT: 2010-12-17 </a:t>
            </a: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3-03-2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442181" y="1922310"/>
            <a:ext cx="348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- 2010-12-17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514099" y="1922310"/>
            <a:ext cx="30925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- 2010-12-17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6414247" y="738664"/>
            <a:ext cx="170110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: </a:t>
            </a:r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6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: 10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3246" y="2423957"/>
            <a:ext cx="6019851" cy="3679740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14247" y="2422479"/>
            <a:ext cx="5592172" cy="3681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764528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0" y="0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19) ID 19, 55/M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8-05-25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12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47197" y="1153546"/>
            <a:ext cx="7585262" cy="47494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25696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0" y="0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20) ID 20, 47/M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4-11-20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7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7172" y="1017459"/>
            <a:ext cx="7178769" cy="47044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182406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0" y="0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21) ID 21, 58/M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6-01-21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18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44446" y="761965"/>
            <a:ext cx="7174566" cy="52976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38100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8964" y="0"/>
            <a:ext cx="801892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22) ID 22, 44/M</a:t>
            </a:r>
            <a:endParaRPr lang="en-US" altLang="ko-KR" baseline="0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endParaRPr lang="en-US" altLang="ko-KR" baseline="0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6-03-09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: 22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05505" y="923330"/>
            <a:ext cx="6836989" cy="49908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9905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17040"/>
            <a:ext cx="11967881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2) ID : 2, 68/M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: 2007-02-07 </a:t>
            </a:r>
          </a:p>
          <a:p>
            <a:r>
              <a:rPr lang="en-US" altLang="ko-KR" baseline="0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: 2013-05-10</a:t>
            </a:r>
          </a:p>
          <a:p>
            <a:endParaRPr lang="en-US" altLang="ko-KR" baseline="0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615974" y="2021933"/>
            <a:ext cx="350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– 2007-02-07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281962" y="2021933"/>
            <a:ext cx="3116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– 2013-05-10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281962" y="545067"/>
            <a:ext cx="169790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 : 3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 : </a:t>
            </a:r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8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4032" y="2575007"/>
            <a:ext cx="5229908" cy="3410810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00799" y="2575007"/>
            <a:ext cx="5123329" cy="3410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6671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0" y="1206"/>
            <a:ext cx="3354123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3) ID : 3, 88/M</a:t>
            </a: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CT: 2010-03-18</a:t>
            </a: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4-08-16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61516" y="2227772"/>
            <a:ext cx="350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– 2010-03-18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415826" y="2165284"/>
            <a:ext cx="3116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– 2014-08-16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415826" y="601370"/>
            <a:ext cx="17459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 : 4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 : 71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215555" y="2597104"/>
            <a:ext cx="4460166" cy="3306675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44611" y="2597104"/>
            <a:ext cx="4066286" cy="3293228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10892" y="2597104"/>
            <a:ext cx="4181108" cy="32932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03361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17746"/>
            <a:ext cx="879081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4) ID : 4, 79/M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CT: 2013-09-02</a:t>
            </a: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3-10-2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886822" y="1629993"/>
            <a:ext cx="350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– 2013-09-02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379519" y="1626541"/>
            <a:ext cx="3116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– 2013-10-21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79519" y="498978"/>
            <a:ext cx="17459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 : 2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 : 14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5071" y="2164133"/>
            <a:ext cx="5926507" cy="3781832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64016" y="2164133"/>
            <a:ext cx="5746327" cy="37611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17601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-1"/>
            <a:ext cx="689186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5) ID 5, 56/F</a:t>
            </a:r>
            <a:endParaRPr lang="en-US" altLang="ko-KR" baseline="0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endParaRPr lang="en-US" altLang="ko-KR" baseline="0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CT: 2009-05-16</a:t>
            </a:r>
          </a:p>
          <a:p>
            <a:r>
              <a:rPr lang="en-US" altLang="ko-KR" baseline="0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3-06-05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871984" y="1875397"/>
            <a:ext cx="350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– 2009-05-16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382467" y="1875397"/>
            <a:ext cx="3116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– 2013-06-05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82467" y="376208"/>
            <a:ext cx="169790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 : 1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 : 7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389" y="2352046"/>
            <a:ext cx="6317214" cy="3712578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18745" y="2352046"/>
            <a:ext cx="5444005" cy="37125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13156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1796"/>
            <a:ext cx="1163170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6) ID 6, 84/M</a:t>
            </a:r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CT: 2009-06-02</a:t>
            </a: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4-02-14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541463" y="1573254"/>
            <a:ext cx="350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– 2009-06-02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441356" y="1573254"/>
            <a:ext cx="3116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– 2014-02-14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441356" y="322407"/>
            <a:ext cx="17459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 : 37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 : 68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0081" y="1986198"/>
            <a:ext cx="5768788" cy="3785767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78869" y="1986198"/>
            <a:ext cx="5641535" cy="37857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1509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-6799"/>
            <a:ext cx="644562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7) ID 7, 71/M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: 2014-10-22</a:t>
            </a:r>
          </a:p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: 2015-12-30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34257" y="1811533"/>
            <a:ext cx="350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– 2014-10-22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393216" y="1808630"/>
            <a:ext cx="3116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– 2015-12-30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93216" y="593365"/>
            <a:ext cx="17459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 : 2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 : 12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8916" y="2254897"/>
            <a:ext cx="5617496" cy="4380225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14001" y="2254897"/>
            <a:ext cx="5474990" cy="4380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2891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" y="0"/>
            <a:ext cx="66548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8) ID 8, 55/M</a:t>
            </a:r>
          </a:p>
          <a:p>
            <a:endParaRPr lang="en-US" altLang="ko-KR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CT: 2014-02-19 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CT: 2018-02-1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181595" y="1568622"/>
            <a:ext cx="350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Pre diagnostic CT – 2014-02-19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506353" y="1568622"/>
            <a:ext cx="2997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Diagnostic CT  2018-02-11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54801" y="270959"/>
            <a:ext cx="17459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Total CT score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initial : 1</a:t>
            </a:r>
          </a:p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</a:rPr>
              <a:t> 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</a:rPr>
              <a:t>- follow up : 10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</a:endParaRPr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0779" y="2032725"/>
            <a:ext cx="3227657" cy="4535369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50644" y="2032726"/>
            <a:ext cx="3091455" cy="4535368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44307" y="2032725"/>
            <a:ext cx="3057245" cy="45252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79463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4</TotalTime>
  <Words>741</Words>
  <Application>Microsoft Office PowerPoint</Application>
  <PresentationFormat>와이드스크린</PresentationFormat>
  <Paragraphs>220</Paragraphs>
  <Slides>23</Slides>
  <Notes>22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3</vt:i4>
      </vt:variant>
    </vt:vector>
  </HeadingPairs>
  <TitlesOfParts>
    <vt:vector size="26" baseType="lpstr">
      <vt:lpstr>Arial Unicode MS</vt:lpstr>
      <vt:lpstr>Arial</vt:lpstr>
      <vt:lpstr>Office 테마</vt:lpstr>
      <vt:lpstr>Representative figures of 22 Patients with predominant CM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V</dc:creator>
  <cp:lastModifiedBy>BON-RAD-006</cp:lastModifiedBy>
  <cp:revision>43</cp:revision>
  <dcterms:created xsi:type="dcterms:W3CDTF">2018-08-14T06:18:02Z</dcterms:created>
  <dcterms:modified xsi:type="dcterms:W3CDTF">2019-12-12T07:07:58Z</dcterms:modified>
</cp:coreProperties>
</file>